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68" r:id="rId2"/>
  </p:sldIdLst>
  <p:sldSz cx="9144000" cy="5715000" type="screen16x1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45E965-0140-ADE0-DB2C-DDC75760A289}" name="Alessandro Fatatis" initials="AF" userId="S::af39@drexel.edu::5421c82d-accb-43d6-bc52-f8c7455fa968" providerId="AD"/>
  <p188:author id="{0D443DB4-5F58-0368-B600-A387FC99D53C}" name="Dinatale,Anthony" initials="D" userId="S::acd84@drexel.edu::4c6ef405-d2be-481c-925d-4add091459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C"/>
    <a:srgbClr val="2125FF"/>
    <a:srgbClr val="00B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11"/>
    <p:restoredTop sz="96327"/>
  </p:normalViewPr>
  <p:slideViewPr>
    <p:cSldViewPr snapToGrid="0" snapToObjects="1">
      <p:cViewPr varScale="1">
        <p:scale>
          <a:sx n="148" d="100"/>
          <a:sy n="148" d="100"/>
        </p:scale>
        <p:origin x="704" y="192"/>
      </p:cViewPr>
      <p:guideLst/>
    </p:cSldViewPr>
  </p:slideViewPr>
  <p:notesTextViewPr>
    <p:cViewPr>
      <p:scale>
        <a:sx n="114" d="100"/>
        <a:sy n="114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9FFED5-8238-1442-BCC4-7B81FEB7EF0C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20975" y="857250"/>
            <a:ext cx="37020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18B98-75F2-1243-9ECC-791F8B5F4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885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1pPr>
    <a:lvl2pPr marL="40812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2pPr>
    <a:lvl3pPr marL="81625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3pPr>
    <a:lvl4pPr marL="122438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4pPr>
    <a:lvl5pPr marL="163250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5pPr>
    <a:lvl6pPr marL="204063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6pPr>
    <a:lvl7pPr marL="2448761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7pPr>
    <a:lvl8pPr marL="2856889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8pPr>
    <a:lvl9pPr marL="326501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20975" y="857250"/>
            <a:ext cx="370205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591124-4521-724D-8BFA-E3EDB7838D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038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935302"/>
            <a:ext cx="6858000" cy="19896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2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04271"/>
            <a:ext cx="1971675" cy="48431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04271"/>
            <a:ext cx="5800725" cy="48431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49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7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424782"/>
            <a:ext cx="7886700" cy="2377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824553"/>
            <a:ext cx="7886700" cy="125015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86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0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271"/>
            <a:ext cx="7886700" cy="11046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400969"/>
            <a:ext cx="3868340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087563"/>
            <a:ext cx="3868340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400969"/>
            <a:ext cx="3887391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087563"/>
            <a:ext cx="3887391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9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656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822855"/>
            <a:ext cx="4629150" cy="406135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48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822855"/>
            <a:ext cx="4629150" cy="406135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0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04271"/>
            <a:ext cx="788670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521354"/>
            <a:ext cx="788670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5296959"/>
            <a:ext cx="30861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7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B4DA261-F752-48F6-A8F8-541FECC86FA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6906" b="50920"/>
          <a:stretch/>
        </p:blipFill>
        <p:spPr>
          <a:xfrm>
            <a:off x="3348620" y="2961471"/>
            <a:ext cx="1734368" cy="158074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278FC5A2-1CDB-DC46-B028-8B3494F680BE}"/>
              </a:ext>
            </a:extLst>
          </p:cNvPr>
          <p:cNvSpPr txBox="1"/>
          <p:nvPr/>
        </p:nvSpPr>
        <p:spPr>
          <a:xfrm>
            <a:off x="2713431" y="1091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1D6E2E3-68FE-594F-A6BD-EEB9A2AD9004}"/>
              </a:ext>
            </a:extLst>
          </p:cNvPr>
          <p:cNvSpPr txBox="1"/>
          <p:nvPr/>
        </p:nvSpPr>
        <p:spPr>
          <a:xfrm>
            <a:off x="2700607" y="28575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F543A9-72A9-BF4E-B1E6-1B9957A820A8}"/>
              </a:ext>
            </a:extLst>
          </p:cNvPr>
          <p:cNvSpPr txBox="1"/>
          <p:nvPr/>
        </p:nvSpPr>
        <p:spPr>
          <a:xfrm>
            <a:off x="180002" y="4838445"/>
            <a:ext cx="866134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Expression of CMV-AR and TRE-AR constructs in PC3-ML cells, confirmed at the transcript level for both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at the protein level for the TRE-AR following addition of doxycycline to the culture medium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EA12BDD-E110-3346-AD20-9EDC4B710E4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4883"/>
          <a:stretch/>
        </p:blipFill>
        <p:spPr>
          <a:xfrm>
            <a:off x="3259913" y="293815"/>
            <a:ext cx="2013324" cy="187657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A27721D-EC09-3A9A-0CF3-533761143A3E}"/>
              </a:ext>
            </a:extLst>
          </p:cNvPr>
          <p:cNvSpPr txBox="1"/>
          <p:nvPr/>
        </p:nvSpPr>
        <p:spPr>
          <a:xfrm>
            <a:off x="4086373" y="2034943"/>
            <a:ext cx="625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B94624C-37E8-E044-64A8-0738A2FD1A9A}"/>
              </a:ext>
            </a:extLst>
          </p:cNvPr>
          <p:cNvSpPr txBox="1"/>
          <p:nvPr/>
        </p:nvSpPr>
        <p:spPr>
          <a:xfrm>
            <a:off x="4411051" y="229509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RE-A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2590BB-E6BA-F982-15FC-EE26B6EB86DE}"/>
              </a:ext>
            </a:extLst>
          </p:cNvPr>
          <p:cNvSpPr txBox="1"/>
          <p:nvPr/>
        </p:nvSpPr>
        <p:spPr>
          <a:xfrm>
            <a:off x="4679805" y="2034943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C3-ML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MV-AR</a:t>
            </a:r>
          </a:p>
        </p:txBody>
      </p:sp>
    </p:spTree>
    <p:extLst>
      <p:ext uri="{BB962C8B-B14F-4D97-AF65-F5344CB8AC3E}">
        <p14:creationId xmlns:p14="http://schemas.microsoft.com/office/powerpoint/2010/main" val="1138690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55</TotalTime>
  <Words>53</Words>
  <Application>Microsoft Macintosh PowerPoint</Application>
  <PresentationFormat>On-screen Show (16:10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o Fatatis</dc:creator>
  <cp:lastModifiedBy>Alessandro Fatatis</cp:lastModifiedBy>
  <cp:revision>255</cp:revision>
  <dcterms:created xsi:type="dcterms:W3CDTF">2021-08-27T21:58:33Z</dcterms:created>
  <dcterms:modified xsi:type="dcterms:W3CDTF">2022-11-02T10:43:02Z</dcterms:modified>
</cp:coreProperties>
</file>